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8446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471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11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4905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1819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0799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5305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7744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8424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0813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1792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F3A6D-1E48-407F-B84D-F796C2ACD584}" type="datetimeFigureOut">
              <a:rPr lang="de-DE" smtClean="0"/>
              <a:t>19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EC667-680F-4019-BABC-C5622D58100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804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4001" y="1959168"/>
            <a:ext cx="2000250" cy="17907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0119" y="304550"/>
            <a:ext cx="1680661" cy="5099937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14373" y="472992"/>
            <a:ext cx="1515061" cy="4764756"/>
          </a:xfrm>
          <a:prstGeom prst="rect">
            <a:avLst/>
          </a:prstGeom>
        </p:spPr>
      </p:pic>
      <p:cxnSp>
        <p:nvCxnSpPr>
          <p:cNvPr id="8" name="Gerade Verbindung mit Pfeil 7"/>
          <p:cNvCxnSpPr/>
          <p:nvPr/>
        </p:nvCxnSpPr>
        <p:spPr>
          <a:xfrm flipH="1">
            <a:off x="2662989" y="986589"/>
            <a:ext cx="1652337" cy="14919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mit Pfeil 8"/>
          <p:cNvCxnSpPr/>
          <p:nvPr/>
        </p:nvCxnSpPr>
        <p:spPr>
          <a:xfrm flipH="1">
            <a:off x="2662989" y="1138989"/>
            <a:ext cx="1652337" cy="149191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2816017" y="2111568"/>
            <a:ext cx="1499310" cy="519337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 flipV="1">
            <a:off x="2662989" y="2854518"/>
            <a:ext cx="1527701" cy="69283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 flipV="1">
            <a:off x="2582154" y="3105169"/>
            <a:ext cx="1670854" cy="1769678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>
            <a:off x="5398920" y="936471"/>
            <a:ext cx="151899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>
            <a:off x="5511214" y="2111568"/>
            <a:ext cx="1518990" cy="0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flipV="1">
            <a:off x="5294647" y="3093616"/>
            <a:ext cx="1735557" cy="483827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V="1">
            <a:off x="5294647" y="4547937"/>
            <a:ext cx="1563353" cy="300855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4FB07AB-E68A-9FC4-F8A7-22DC2EBDFF42}"/>
              </a:ext>
            </a:extLst>
          </p:cNvPr>
          <p:cNvSpPr txBox="1"/>
          <p:nvPr/>
        </p:nvSpPr>
        <p:spPr>
          <a:xfrm>
            <a:off x="2020389" y="5747657"/>
            <a:ext cx="94836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err="1"/>
              <a:t>S1</a:t>
            </a:r>
            <a:r>
              <a:rPr lang="en-US" dirty="0"/>
              <a:t>. Comparison of the graphic abstract of our 3D skin equivalent and immunostaining of skin layer markers to further demonstrate the </a:t>
            </a:r>
            <a:r>
              <a:rPr lang="en-US" dirty="0" err="1"/>
              <a:t>succesful</a:t>
            </a:r>
            <a:r>
              <a:rPr lang="en-US" dirty="0"/>
              <a:t> stratification of our 3D skin equivalent.</a:t>
            </a:r>
          </a:p>
        </p:txBody>
      </p:sp>
    </p:spTree>
    <p:extLst>
      <p:ext uri="{BB962C8B-B14F-4D97-AF65-F5344CB8AC3E}">
        <p14:creationId xmlns:p14="http://schemas.microsoft.com/office/powerpoint/2010/main" val="2258061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uwayhid, Rima</dc:creator>
  <cp:lastModifiedBy>MDPI</cp:lastModifiedBy>
  <cp:revision>2</cp:revision>
  <dcterms:created xsi:type="dcterms:W3CDTF">2024-01-02T12:36:41Z</dcterms:created>
  <dcterms:modified xsi:type="dcterms:W3CDTF">2024-01-19T02:09:02Z</dcterms:modified>
</cp:coreProperties>
</file>